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62" r:id="rId3"/>
    <p:sldId id="263" r:id="rId4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652" autoAdjust="0"/>
    <p:restoredTop sz="94660"/>
  </p:normalViewPr>
  <p:slideViewPr>
    <p:cSldViewPr snapToGrid="0">
      <p:cViewPr>
        <p:scale>
          <a:sx n="70" d="100"/>
          <a:sy n="70" d="100"/>
        </p:scale>
        <p:origin x="99" y="-83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24510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58427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63590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44473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68594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05075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34542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97976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22645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7122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6619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C8F292-8547-4AC4-9467-286598DF4F4C}" type="datetimeFigureOut">
              <a:rPr lang="zh-TW" altLang="en-US" smtClean="0"/>
              <a:t>2020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7B3047-2CCB-4B0F-A6E1-1157ECE23D7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48307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格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646461"/>
              </p:ext>
            </p:extLst>
          </p:nvPr>
        </p:nvGraphicFramePr>
        <p:xfrm>
          <a:off x="487278" y="1967899"/>
          <a:ext cx="5915022" cy="1281344"/>
        </p:xfrm>
        <a:graphic>
          <a:graphicData uri="http://schemas.openxmlformats.org/drawingml/2006/table">
            <a:tbl>
              <a:tblPr/>
              <a:tblGrid>
                <a:gridCol w="475249">
                  <a:extLst>
                    <a:ext uri="{9D8B030D-6E8A-4147-A177-3AD203B41FA5}">
                      <a16:colId xmlns:a16="http://schemas.microsoft.com/office/drawing/2014/main" val="878154229"/>
                    </a:ext>
                  </a:extLst>
                </a:gridCol>
                <a:gridCol w="475249">
                  <a:extLst>
                    <a:ext uri="{9D8B030D-6E8A-4147-A177-3AD203B41FA5}">
                      <a16:colId xmlns:a16="http://schemas.microsoft.com/office/drawing/2014/main" val="2168278841"/>
                    </a:ext>
                  </a:extLst>
                </a:gridCol>
                <a:gridCol w="562988">
                  <a:extLst>
                    <a:ext uri="{9D8B030D-6E8A-4147-A177-3AD203B41FA5}">
                      <a16:colId xmlns:a16="http://schemas.microsoft.com/office/drawing/2014/main" val="3796780161"/>
                    </a:ext>
                  </a:extLst>
                </a:gridCol>
                <a:gridCol w="922656">
                  <a:extLst>
                    <a:ext uri="{9D8B030D-6E8A-4147-A177-3AD203B41FA5}">
                      <a16:colId xmlns:a16="http://schemas.microsoft.com/office/drawing/2014/main" val="1570425512"/>
                    </a:ext>
                  </a:extLst>
                </a:gridCol>
                <a:gridCol w="421105">
                  <a:extLst>
                    <a:ext uri="{9D8B030D-6E8A-4147-A177-3AD203B41FA5}">
                      <a16:colId xmlns:a16="http://schemas.microsoft.com/office/drawing/2014/main" val="2396991306"/>
                    </a:ext>
                  </a:extLst>
                </a:gridCol>
                <a:gridCol w="396382">
                  <a:extLst>
                    <a:ext uri="{9D8B030D-6E8A-4147-A177-3AD203B41FA5}">
                      <a16:colId xmlns:a16="http://schemas.microsoft.com/office/drawing/2014/main" val="4086407946"/>
                    </a:ext>
                  </a:extLst>
                </a:gridCol>
                <a:gridCol w="380199">
                  <a:extLst>
                    <a:ext uri="{9D8B030D-6E8A-4147-A177-3AD203B41FA5}">
                      <a16:colId xmlns:a16="http://schemas.microsoft.com/office/drawing/2014/main" val="3368358763"/>
                    </a:ext>
                  </a:extLst>
                </a:gridCol>
                <a:gridCol w="380199">
                  <a:extLst>
                    <a:ext uri="{9D8B030D-6E8A-4147-A177-3AD203B41FA5}">
                      <a16:colId xmlns:a16="http://schemas.microsoft.com/office/drawing/2014/main" val="2769290998"/>
                    </a:ext>
                  </a:extLst>
                </a:gridCol>
                <a:gridCol w="380199">
                  <a:extLst>
                    <a:ext uri="{9D8B030D-6E8A-4147-A177-3AD203B41FA5}">
                      <a16:colId xmlns:a16="http://schemas.microsoft.com/office/drawing/2014/main" val="159663239"/>
                    </a:ext>
                  </a:extLst>
                </a:gridCol>
                <a:gridCol w="380199">
                  <a:extLst>
                    <a:ext uri="{9D8B030D-6E8A-4147-A177-3AD203B41FA5}">
                      <a16:colId xmlns:a16="http://schemas.microsoft.com/office/drawing/2014/main" val="878368434"/>
                    </a:ext>
                  </a:extLst>
                </a:gridCol>
                <a:gridCol w="380199">
                  <a:extLst>
                    <a:ext uri="{9D8B030D-6E8A-4147-A177-3AD203B41FA5}">
                      <a16:colId xmlns:a16="http://schemas.microsoft.com/office/drawing/2014/main" val="3545469973"/>
                    </a:ext>
                  </a:extLst>
                </a:gridCol>
                <a:gridCol w="380199">
                  <a:extLst>
                    <a:ext uri="{9D8B030D-6E8A-4147-A177-3AD203B41FA5}">
                      <a16:colId xmlns:a16="http://schemas.microsoft.com/office/drawing/2014/main" val="2930485360"/>
                    </a:ext>
                  </a:extLst>
                </a:gridCol>
                <a:gridCol w="380199">
                  <a:extLst>
                    <a:ext uri="{9D8B030D-6E8A-4147-A177-3AD203B41FA5}">
                      <a16:colId xmlns:a16="http://schemas.microsoft.com/office/drawing/2014/main" val="353220370"/>
                    </a:ext>
                  </a:extLst>
                </a:gridCol>
              </a:tblGrid>
              <a:tr h="22482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roupname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_genes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_dpna_genes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xp_range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rrelation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_value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an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d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n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Q1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dian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Q3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x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949431"/>
                  </a:ext>
                </a:extLst>
              </a:tr>
              <a:tr h="211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st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704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604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&lt; exp &lt;=1.78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84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.534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.729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111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833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.286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6.333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5534880"/>
                  </a:ext>
                </a:extLst>
              </a:tr>
              <a:tr h="211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nd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705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686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78&lt; exp &lt;=7.78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109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.089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.165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128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462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.744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4.761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4834698"/>
                  </a:ext>
                </a:extLst>
              </a:tr>
              <a:tr h="211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rd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704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701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78&lt; exp &lt;=17.10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72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.317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.623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196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.518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8.665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6.846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4518338"/>
                  </a:ext>
                </a:extLst>
              </a:tr>
              <a:tr h="211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th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705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702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.10&lt; exp &lt;=38.67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11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453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.127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.033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226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.079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7.973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8.105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330910"/>
                  </a:ext>
                </a:extLst>
              </a:tr>
              <a:tr h="211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th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705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696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8.67&lt;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xp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&lt;=126785.00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32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28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.017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.669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102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33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.664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8.214</a:t>
                      </a:r>
                    </a:p>
                  </a:txBody>
                  <a:tcPr marL="2742" marR="2742" marT="274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7286345"/>
                  </a:ext>
                </a:extLst>
              </a:tr>
            </a:tbl>
          </a:graphicData>
        </a:graphic>
      </p:graphicFrame>
      <p:sp>
        <p:nvSpPr>
          <p:cNvPr id="10" name="矩形 9"/>
          <p:cNvSpPr/>
          <p:nvPr/>
        </p:nvSpPr>
        <p:spPr>
          <a:xfrm>
            <a:off x="487278" y="1365358"/>
            <a:ext cx="588143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TW" sz="1200" b="1" dirty="0">
                <a:solidFill>
                  <a:prstClr val="black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US" altLang="zh-TW" sz="1200" b="1" dirty="0" smtClean="0">
                <a:solidFill>
                  <a:prstClr val="black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S1. The output spreadsheet of Figure 4B from grouping statistics.</a:t>
            </a:r>
            <a:endParaRPr lang="en-US" altLang="zh-TW" sz="1200" b="1" dirty="0">
              <a:solidFill>
                <a:prstClr val="black"/>
              </a:solidFill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00919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8008" y="1205256"/>
            <a:ext cx="4078300" cy="3058725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834439" y="5243129"/>
            <a:ext cx="540067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The correlation between TE methylation and TE expression from </a:t>
            </a:r>
            <a:r>
              <a:rPr lang="en-US" altLang="zh-TW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GET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rabidopsis).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 the WGBS data </a:t>
            </a:r>
            <a:r>
              <a:rPr lang="da-DK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Yen, Suen et al. 2017)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RNA-</a:t>
            </a:r>
            <a:r>
              <a:rPr lang="en-US" altLang="zh-TW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it-IT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rejo-Arellano, Mehdi et al. 2020)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TE analyses in Arabidopsis. The gene here refers to TE in </a:t>
            </a:r>
            <a:r>
              <a:rPr lang="en-US" altLang="zh-TW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GET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the </a:t>
            </a:r>
            <a:r>
              <a:rPr lang="en-US" altLang="zh-TW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gene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lot shows that highly expressed genes are relatively low CHG methylation level around TE.</a:t>
            </a:r>
          </a:p>
        </p:txBody>
      </p:sp>
      <p:sp>
        <p:nvSpPr>
          <p:cNvPr id="6" name="文字方塊 5"/>
          <p:cNvSpPr txBox="1"/>
          <p:nvPr/>
        </p:nvSpPr>
        <p:spPr>
          <a:xfrm>
            <a:off x="2919674" y="955801"/>
            <a:ext cx="12302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srgbClr val="002060"/>
                </a:solidFill>
              </a:rPr>
              <a:t>Arabidopsis</a:t>
            </a:r>
            <a:endParaRPr lang="en-US" sz="1600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295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4884" y="1640306"/>
            <a:ext cx="2722500" cy="2178000"/>
          </a:xfrm>
          <a:prstGeom prst="rect">
            <a:avLst/>
          </a:prstGeom>
        </p:spPr>
      </p:pic>
      <p:pic>
        <p:nvPicPr>
          <p:cNvPr id="4" name="圖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6595" y="1640306"/>
            <a:ext cx="2722141" cy="2177713"/>
          </a:xfrm>
          <a:prstGeom prst="rect">
            <a:avLst/>
          </a:prstGeom>
        </p:spPr>
      </p:pic>
      <p:sp>
        <p:nvSpPr>
          <p:cNvPr id="5" name="Rectangle 6"/>
          <p:cNvSpPr>
            <a:spLocks noChangeArrowheads="1"/>
          </p:cNvSpPr>
          <p:nvPr/>
        </p:nvSpPr>
        <p:spPr bwMode="auto">
          <a:xfrm>
            <a:off x="-41007" y="1203857"/>
            <a:ext cx="377699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304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TW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A</a:t>
            </a:r>
            <a:r>
              <a:rPr kumimoji="0" lang="en-US" altLang="zh-TW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         </a:t>
            </a:r>
            <a:r>
              <a:rPr kumimoji="0" lang="zh-TW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        </a:t>
            </a:r>
            <a:r>
              <a:rPr kumimoji="0" lang="en-US" altLang="zh-TW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              </a:t>
            </a:r>
            <a:r>
              <a:rPr kumimoji="0" lang="zh-TW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                                 </a:t>
            </a:r>
            <a:r>
              <a:rPr kumimoji="0" lang="en-US" altLang="zh-TW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B</a:t>
            </a:r>
            <a:endParaRPr kumimoji="0" lang="en-US" altLang="zh-TW" sz="3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606595" y="4501680"/>
            <a:ext cx="546935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TW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altLang="zh-TW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T</a:t>
            </a:r>
            <a:r>
              <a:rPr lang="en-US" altLang="zh-TW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 </a:t>
            </a:r>
            <a:r>
              <a:rPr lang="en-US" altLang="zh-TW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genic CHH methylation and gene expression in </a:t>
            </a:r>
            <a:r>
              <a:rPr lang="en-US" altLang="zh-TW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 genes and non-TE-related </a:t>
            </a:r>
            <a:r>
              <a:rPr lang="en-US" altLang="zh-TW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s. </a:t>
            </a:r>
            <a:r>
              <a:rPr lang="en-US" altLang="zh-TW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TW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is is </a:t>
            </a:r>
            <a:r>
              <a:rPr lang="en-US" altLang="zh-TW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TW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B </a:t>
            </a:r>
            <a:r>
              <a:rPr lang="en-US" altLang="zh-TW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at shows most </a:t>
            </a:r>
            <a:r>
              <a:rPr lang="en-US" altLang="zh-TW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fferential genes </a:t>
            </a:r>
            <a:r>
              <a:rPr lang="en-US" altLang="zh-TW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creases </a:t>
            </a:r>
            <a:r>
              <a:rPr lang="en-US" altLang="zh-TW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both CHH methylation and gene expression in gene body regions.</a:t>
            </a:r>
            <a:r>
              <a:rPr lang="en-US" altLang="zh-TW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B</a:t>
            </a:r>
            <a:r>
              <a:rPr lang="en-US" altLang="zh-TW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TW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 </a:t>
            </a:r>
            <a:r>
              <a:rPr lang="en-US" altLang="zh-TW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moved TE-related genes (identified by The MSU Rice Genome Annotation Project (Release 7)) from the gene expression inputs of </a:t>
            </a:r>
            <a:r>
              <a:rPr lang="en-US" altLang="zh-TW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hGET</a:t>
            </a:r>
            <a:r>
              <a:rPr lang="en-US" altLang="zh-TW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The result shows similar patterns in non-TE-related genes that </a:t>
            </a:r>
            <a:r>
              <a:rPr lang="en-US" altLang="zh-TW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s with extreme values are enriched in the third </a:t>
            </a:r>
            <a:r>
              <a:rPr lang="en-US" altLang="zh-TW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uadrants. This </a:t>
            </a:r>
            <a:r>
              <a:rPr lang="en-US" altLang="zh-TW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cates that the positive correlation between genic CHH methylation and gene expression still holds in the absence of TE-related genes.</a:t>
            </a:r>
            <a:endParaRPr lang="en-US" dirty="0"/>
          </a:p>
        </p:txBody>
      </p:sp>
      <p:sp>
        <p:nvSpPr>
          <p:cNvPr id="8" name="文字方塊 7"/>
          <p:cNvSpPr txBox="1"/>
          <p:nvPr/>
        </p:nvSpPr>
        <p:spPr>
          <a:xfrm>
            <a:off x="1731239" y="1211236"/>
            <a:ext cx="1230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002060"/>
                </a:solidFill>
              </a:rPr>
              <a:t>Rice</a:t>
            </a:r>
            <a:endParaRPr lang="en-US" sz="1400" dirty="0">
              <a:solidFill>
                <a:srgbClr val="002060"/>
              </a:solidFill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4510534" y="1211235"/>
            <a:ext cx="1230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002060"/>
                </a:solidFill>
              </a:rPr>
              <a:t>Rice</a:t>
            </a:r>
            <a:endParaRPr lang="en-US" sz="1400" dirty="0">
              <a:solidFill>
                <a:srgbClr val="002060"/>
              </a:solidFill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1641184" y="1496330"/>
            <a:ext cx="12302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rgbClr val="002060"/>
                </a:solidFill>
              </a:rPr>
              <a:t>All genes</a:t>
            </a:r>
            <a:endParaRPr lang="en-US" sz="1100" dirty="0">
              <a:solidFill>
                <a:srgbClr val="002060"/>
              </a:solidFill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4103281" y="1486102"/>
            <a:ext cx="15023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rgbClr val="002060"/>
                </a:solidFill>
              </a:rPr>
              <a:t>Non-TE-related genes</a:t>
            </a:r>
            <a:endParaRPr lang="en-US" sz="1100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5332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93</TotalTime>
  <Words>311</Words>
  <Application>Microsoft Office PowerPoint</Application>
  <PresentationFormat>A4 紙張 (210x297 公釐)</PresentationFormat>
  <Paragraphs>87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Jason Teng</dc:creator>
  <cp:lastModifiedBy>Jason Teng</cp:lastModifiedBy>
  <cp:revision>52</cp:revision>
  <dcterms:created xsi:type="dcterms:W3CDTF">2019-07-09T02:33:54Z</dcterms:created>
  <dcterms:modified xsi:type="dcterms:W3CDTF">2020-03-10T13:44:56Z</dcterms:modified>
</cp:coreProperties>
</file>